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-928" y="-1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8676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13931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2679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0699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7771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953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184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7636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0792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32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7691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B0059-85BB-4B7B-9F3C-E8FB367414A7}" type="datetimeFigureOut">
              <a:rPr lang="de-DE" smtClean="0"/>
              <a:t>01.10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9D278-EA10-4C47-9FE7-F166CA47DB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181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6613231"/>
              </p:ext>
            </p:extLst>
          </p:nvPr>
        </p:nvGraphicFramePr>
        <p:xfrm>
          <a:off x="984504" y="480854"/>
          <a:ext cx="10515600" cy="1828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605766"/>
                <a:gridCol w="1644640"/>
                <a:gridCol w="1644640"/>
                <a:gridCol w="1598371"/>
                <a:gridCol w="1598371"/>
                <a:gridCol w="1423812"/>
              </a:tblGrid>
              <a:tr h="0">
                <a:tc row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Origin of the sample</a:t>
                      </a:r>
                      <a:endParaRPr lang="de-DE" sz="12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ESBL gene positive 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MDR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Total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No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%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No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%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0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SURGICAL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34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9.6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5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96.5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7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MEDICAL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8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9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8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9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2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EDIATRICS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4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8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0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5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ORTHOPEDICS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ICU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8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72.7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1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00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1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OPD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7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38.9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7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94.4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8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Total</a:t>
                      </a:r>
                      <a:endParaRPr lang="de-DE" sz="12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71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63.4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07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95.5</a:t>
                      </a:r>
                      <a:endParaRPr lang="de-DE" sz="120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38100" marR="38100">
                        <a:lnSpc>
                          <a:spcPts val="16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12</a:t>
                      </a:r>
                      <a:endParaRPr lang="de-DE" sz="1200" dirty="0">
                        <a:effectLst/>
                        <a:latin typeface="Cambria" panose="02040503050406030204" pitchFamily="18" charset="0"/>
                        <a:ea typeface="MS Mincho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886534" y="2844177"/>
            <a:ext cx="87849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u="sng" dirty="0" smtClean="0"/>
              <a:t>Additional </a:t>
            </a:r>
            <a:r>
              <a:rPr lang="de-DE" sz="1200" b="1" u="sng" dirty="0" err="1" smtClean="0"/>
              <a:t>file</a:t>
            </a:r>
            <a:r>
              <a:rPr lang="de-DE" sz="1200" b="1" u="sng" dirty="0" smtClean="0"/>
              <a:t> 2:</a:t>
            </a:r>
            <a:r>
              <a:rPr lang="de-DE" sz="1200" u="sng" dirty="0" smtClean="0"/>
              <a:t> </a:t>
            </a:r>
          </a:p>
          <a:p>
            <a:r>
              <a:rPr lang="de-DE" sz="1200" u="sng" dirty="0" smtClean="0"/>
              <a:t>Rates of ESBL and MDR in </a:t>
            </a:r>
            <a:r>
              <a:rPr lang="de-DE" sz="1200" u="sng" dirty="0" err="1" smtClean="0"/>
              <a:t>view</a:t>
            </a:r>
            <a:r>
              <a:rPr lang="de-DE" sz="1200" u="sng" dirty="0" smtClean="0"/>
              <a:t> of different </a:t>
            </a:r>
            <a:r>
              <a:rPr lang="de-DE" sz="1200" u="sng" dirty="0" err="1" smtClean="0"/>
              <a:t>hospital</a:t>
            </a:r>
            <a:r>
              <a:rPr lang="de-DE" sz="1200" u="sng" dirty="0" smtClean="0"/>
              <a:t> </a:t>
            </a:r>
            <a:r>
              <a:rPr lang="de-DE" sz="1200" u="sng" smtClean="0"/>
              <a:t>departments</a:t>
            </a:r>
            <a:endParaRPr lang="de-DE" sz="1200" u="sng" dirty="0"/>
          </a:p>
        </p:txBody>
      </p:sp>
    </p:spTree>
    <p:extLst>
      <p:ext uri="{BB962C8B-B14F-4D97-AF65-F5344CB8AC3E}">
        <p14:creationId xmlns:p14="http://schemas.microsoft.com/office/powerpoint/2010/main" val="26076948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Macintosh PowerPoint</Application>
  <PresentationFormat>Benutzerdefiniert</PresentationFormat>
  <Paragraphs>5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Pritsch</dc:creator>
  <cp:lastModifiedBy>Michael Pritsch</cp:lastModifiedBy>
  <cp:revision>4</cp:revision>
  <dcterms:created xsi:type="dcterms:W3CDTF">2018-06-29T11:22:35Z</dcterms:created>
  <dcterms:modified xsi:type="dcterms:W3CDTF">2018-10-01T07:26:58Z</dcterms:modified>
</cp:coreProperties>
</file>